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93443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35925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8626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75331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028415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26186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5988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262461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98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82011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10725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C3D4C1-AAC0-4858-B51A-BB87B58F9467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14094B-ABED-472C-8870-677211E9B6B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88355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90" name="Group 50"/>
          <p:cNvGraphicFramePr>
            <a:graphicFrameLocks noGrp="1"/>
          </p:cNvGraphicFramePr>
          <p:nvPr>
            <p:ph idx="1"/>
          </p:nvPr>
        </p:nvGraphicFramePr>
        <p:xfrm>
          <a:off x="611188" y="620713"/>
          <a:ext cx="7489825" cy="2801938"/>
        </p:xfrm>
        <a:graphic>
          <a:graphicData uri="http://schemas.openxmlformats.org/drawingml/2006/table">
            <a:tbl>
              <a:tblPr/>
              <a:tblGrid>
                <a:gridCol w="1223962"/>
                <a:gridCol w="2160588"/>
                <a:gridCol w="2101850"/>
                <a:gridCol w="2003425"/>
              </a:tblGrid>
              <a:tr h="2460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ene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Forward (5´- 3´) 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Reverse (5´- 3´)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ccession/locus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tIPT1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ctcaacttccacctcc</a:t>
                      </a:r>
                      <a:endParaRPr kumimoji="0" lang="cs-CZ" altLang="cs-CZ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ttccgtgaccgtgact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B061400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tIPT2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gtaagagaaccactcgaca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ttttcatgagctatttgaattc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B062609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tIPT3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tttcaggaacgagcagt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tggaccttcgctttgta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B062610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tIPT5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cttgtttgcttgcgtgta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cttctttcgtcatcgtc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B061403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tIPT9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catttcgtaagacgagagg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ccggataaaatgaagcagtg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NM_001203415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Actin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ttgcaccaagcagcatgaa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cgatccagacactgtacttcctt</a:t>
                      </a:r>
                      <a:endParaRPr kumimoji="0" lang="cs-CZ" altLang="cs-CZ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NM_112764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65125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EF1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gagcacgctcttcttgctttca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ggtggtggcatccatcttgttaca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NM_001125992</a:t>
                      </a: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11313" name="Obdélník 4"/>
          <p:cNvSpPr>
            <a:spLocks noChangeArrowheads="1"/>
          </p:cNvSpPr>
          <p:nvPr/>
        </p:nvSpPr>
        <p:spPr bwMode="auto">
          <a:xfrm>
            <a:off x="611188" y="3573463"/>
            <a:ext cx="74898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cs-CZ" altLang="cs-CZ" sz="1200" b="1">
                <a:latin typeface="Arial" charset="0"/>
              </a:rPr>
              <a:t>Additional file 10. Sequences of Arabidopsis primers used for qPCR analysis.</a:t>
            </a:r>
          </a:p>
        </p:txBody>
      </p:sp>
    </p:spTree>
    <p:extLst>
      <p:ext uri="{BB962C8B-B14F-4D97-AF65-F5344CB8AC3E}">
        <p14:creationId xmlns:p14="http://schemas.microsoft.com/office/powerpoint/2010/main" val="31865127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Předvádění na obrazovce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</cp:revision>
  <dcterms:created xsi:type="dcterms:W3CDTF">2014-10-10T16:05:32Z</dcterms:created>
  <dcterms:modified xsi:type="dcterms:W3CDTF">2014-10-10T16:05:56Z</dcterms:modified>
</cp:coreProperties>
</file>